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56" r:id="rId2"/>
    <p:sldId id="277" r:id="rId3"/>
    <p:sldId id="257" r:id="rId4"/>
    <p:sldId id="258" r:id="rId5"/>
    <p:sldId id="273" r:id="rId6"/>
    <p:sldId id="259" r:id="rId7"/>
    <p:sldId id="260" r:id="rId8"/>
    <p:sldId id="261" r:id="rId9"/>
    <p:sldId id="278" r:id="rId10"/>
    <p:sldId id="264" r:id="rId11"/>
    <p:sldId id="262" r:id="rId12"/>
    <p:sldId id="274" r:id="rId13"/>
    <p:sldId id="275" r:id="rId14"/>
    <p:sldId id="276" r:id="rId15"/>
    <p:sldId id="270" r:id="rId16"/>
    <p:sldId id="279" r:id="rId17"/>
    <p:sldId id="280" r:id="rId18"/>
  </p:sldIdLst>
  <p:sldSz cx="12192000" cy="6858000"/>
  <p:notesSz cx="6858000" cy="9144000"/>
  <p:defaultTextStyle>
    <a:defPPr>
      <a:defRPr lang="zh-Hans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1" autoAdjust="0"/>
    <p:restoredTop sz="94660"/>
  </p:normalViewPr>
  <p:slideViewPr>
    <p:cSldViewPr snapToGrid="0">
      <p:cViewPr varScale="1">
        <p:scale>
          <a:sx n="58" d="100"/>
          <a:sy n="58" d="100"/>
        </p:scale>
        <p:origin x="56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Hans-HK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591F12-8398-4638-8DA0-41BC9EFAE83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Hans-HK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Hans-HK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564362-9AFA-4FCC-BD6D-4AD92C37B963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3797482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Hans-HK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564362-9AFA-4FCC-BD6D-4AD92C37B963}" type="slidenum">
              <a:rPr lang="zh-Hans-HK" altLang="en-US" smtClean="0"/>
              <a:t>10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8845856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51041F-0078-487A-B280-BA9105EBC5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277D6D2-991C-4002-8F03-370D14CF1A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Hans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49CF2C8-1B67-4653-A5E1-F050696F8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2B3EC9-B61A-440E-9AFA-7869748F1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1358257-AA0B-48DE-A91B-4951C7CEA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3422366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87F036-6144-41B3-BBD9-C2E398C32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D2F2576-7E6E-42F7-9BB4-498CAFD640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668146-C885-46EF-8500-735BE8234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2A05C7-2A4B-414F-90F1-5898E5C90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8A7BC6-5747-47D0-B353-41AF5C099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3332151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C27C844-3DAA-4FE0-93F2-CD8C5CD7C3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FA5A757-0E45-46D3-87D8-200EB703D9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E6938C-BABA-4A52-A8FF-9CC156640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E849C5-FFF6-4FBF-9F31-B2F256F23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410024-1F32-4AED-85FB-0A7D674CD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1033480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8A1B2B-A4F7-4012-B30A-72AF2E04CC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122587F-B69F-4F72-8FC5-D627221B43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C031A1-89CE-4992-A4CC-4CE43E36E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23B518-75EE-4FD6-AA33-1AF7E7C52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EAE888-C865-48B4-8333-0ADA7C999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106625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7FF190-4A2A-4D72-9BA1-B08079728A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A7DCCD7-F07B-494B-A72A-B5F1FB6613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413330-93DD-41D8-80C7-80C655225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D28DD6-E09C-4559-ADD5-1D81D83E0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A50FC0-2B25-4088-899D-F4962040B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449739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AA47BF-D654-4C86-821A-D2FCA832A6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7E10407-9DBF-47E0-A8ED-66DA6AACC5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55CEFF5-12EF-4D25-B119-2632B4E91E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E0BCB7-2AC2-47E0-8EFF-BBD75E29D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3E4A0D4-E1EB-4398-9148-98750B545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92C4188-83FC-4DA3-A698-ADA845939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3469000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04A9DE-C5D7-4AC8-ABE8-3035360E0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01F6BBD-F053-4067-A02E-316067EE0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1C30008-E639-4CF8-AC99-26410D800D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B4E2839-30CB-496A-A6E7-E154511467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ED86450-9DBF-45E9-A7B6-EC3D9D5509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34FC5C4-E581-404A-B460-C2D34442A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02CE5D4-7CCE-4FEA-A0E4-ED7E016FE3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4D69559-5518-460F-BE6C-110A9C92D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1947282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A8417E-9A4C-4DC1-A788-ACB96571CC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C45EE36-7838-4398-B1F8-B3C96DBF4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F2E848A-A564-4F71-9EBD-A59CD3B5B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E91A293-5192-437A-8F09-48CB81571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2954720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717106D-62CD-4269-9694-602751432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05BF980-5D84-412B-9324-A04330B34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EF6FADC-9444-4E80-8154-7E7D739B6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295950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BDC5A9-43BF-460F-AFAE-89A9CDABDA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C4ED147-D650-45CE-B335-2324B429BB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8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8EEC8DE-056A-46A2-9F4E-D238F052DA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680B6C-4AF4-4F1C-9FB2-57D08EA22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BB9E379-7807-40C1-AD39-C2B628FA6F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2471ED1-BBE1-4AD6-863C-1DF5238772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1084506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8FE940-C9FF-4FE1-89C5-158284430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1A72A9F-752D-4812-8E1D-4219D34A7F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8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Hans-HK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18B1710-D67A-4E19-9E4B-2A02AE5345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5947E6-AC52-44CD-A5AC-79C73612C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2748A56-2B0B-4AE0-ABBC-997F6B082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ans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C37375-67F6-4E33-A2AA-40BDD94318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2506434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13CD4D5-23D3-444D-99FF-12F92378BE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Hans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E654FF-83EF-43A0-A636-69006A60BC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ans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803C98-F05A-4AC5-9407-F9AEFA7B9A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B988D-9E96-4486-990E-168FC48BDF74}" type="datetimeFigureOut">
              <a:rPr lang="zh-Hans-HK" altLang="en-US" smtClean="0"/>
              <a:t>30/1/2021</a:t>
            </a:fld>
            <a:endParaRPr lang="zh-Hans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BD1393-F22E-4CD8-B151-29487917F0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ans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4AAA36-5598-4676-91BD-7ADB9D1FC7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CC7DE-5CCB-4A0B-A3D3-B2FB756AD00F}" type="slidenum">
              <a:rPr lang="zh-Hans-HK" altLang="en-US" smtClean="0"/>
              <a:t>‹#›</a:t>
            </a:fld>
            <a:endParaRPr lang="zh-Hans-HK" altLang="en-US"/>
          </a:p>
        </p:txBody>
      </p:sp>
    </p:spTree>
    <p:extLst>
      <p:ext uri="{BB962C8B-B14F-4D97-AF65-F5344CB8AC3E}">
        <p14:creationId xmlns:p14="http://schemas.microsoft.com/office/powerpoint/2010/main" val="3418213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ans-H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AFD366-F110-4D3C-AD3D-7D8482868F4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Hans-HK" sz="20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ng et al. </a:t>
            </a:r>
            <a:r>
              <a:rPr lang="en-US" altLang="zh-Hans-HK" sz="2000" dirty="0">
                <a:latin typeface="Arial" panose="020B0604020202020204" pitchFamily="34" charset="0"/>
                <a:cs typeface="Arial" panose="020B0604020202020204" pitchFamily="34" charset="0"/>
              </a:rPr>
              <a:t>uncropped versions of gels or blots</a:t>
            </a:r>
            <a:endParaRPr lang="zh-Hans-HK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74981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2">
            <a:extLst>
              <a:ext uri="{FF2B5EF4-FFF2-40B4-BE49-F238E27FC236}">
                <a16:creationId xmlns:a16="http://schemas.microsoft.com/office/drawing/2014/main" id="{EB40E310-328B-4A18-A1FB-39581C863732}"/>
              </a:ext>
            </a:extLst>
          </p:cNvPr>
          <p:cNvSpPr txBox="1"/>
          <p:nvPr/>
        </p:nvSpPr>
        <p:spPr>
          <a:xfrm>
            <a:off x="81665" y="115519"/>
            <a:ext cx="3641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5b </a:t>
            </a:r>
            <a:r>
              <a:rPr lang="en-US" altLang="zh-CN" b="1" dirty="0"/>
              <a:t>&amp; Supplementary Fig 6d -1</a:t>
            </a:r>
            <a:endParaRPr lang="zh-Hans-HK" altLang="en-US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03CE148-BC67-4011-88A9-0EB10A180840}"/>
              </a:ext>
            </a:extLst>
          </p:cNvPr>
          <p:cNvSpPr txBox="1"/>
          <p:nvPr/>
        </p:nvSpPr>
        <p:spPr>
          <a:xfrm>
            <a:off x="9134176" y="5257562"/>
            <a:ext cx="305782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2: Abcam, ab36495;</a:t>
            </a:r>
            <a:endParaRPr lang="en-US" altLang="zh-Hans-HK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I3K p85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4292;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Phospho-PI3 Kinase p85 (Tyr458)/p55 (Tyr199): 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17366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8046F1A5-18B8-48C6-86D0-0D9AE2C2E6C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31860" y="756839"/>
            <a:ext cx="8602316" cy="5614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309366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>
            <a:extLst>
              <a:ext uri="{FF2B5EF4-FFF2-40B4-BE49-F238E27FC236}">
                <a16:creationId xmlns:a16="http://schemas.microsoft.com/office/drawing/2014/main" id="{15A0324E-54E8-4036-A5C2-4EC021A09589}"/>
              </a:ext>
            </a:extLst>
          </p:cNvPr>
          <p:cNvSpPr txBox="1"/>
          <p:nvPr/>
        </p:nvSpPr>
        <p:spPr>
          <a:xfrm>
            <a:off x="81665" y="115519"/>
            <a:ext cx="3641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5b </a:t>
            </a:r>
            <a:r>
              <a:rPr lang="en-US" altLang="zh-CN" b="1" dirty="0"/>
              <a:t>&amp; Supplementary Fig 6d -2</a:t>
            </a:r>
            <a:endParaRPr lang="zh-Hans-HK" altLang="en-US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8ABB330-A3E0-4C76-9484-67E7858FF131}"/>
              </a:ext>
            </a:extLst>
          </p:cNvPr>
          <p:cNvSpPr txBox="1"/>
          <p:nvPr/>
        </p:nvSpPr>
        <p:spPr>
          <a:xfrm>
            <a:off x="9134176" y="5487029"/>
            <a:ext cx="305782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4691;</a:t>
            </a:r>
            <a:endParaRPr lang="en-US" altLang="zh-Hans-HK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Phospho-AKT: 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9271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F96868FE-D33F-449A-9EA1-43B4EE966ACB}"/>
              </a:ext>
            </a:extLst>
          </p:cNvPr>
          <p:cNvGrpSpPr/>
          <p:nvPr/>
        </p:nvGrpSpPr>
        <p:grpSpPr>
          <a:xfrm>
            <a:off x="390939" y="1131475"/>
            <a:ext cx="9777743" cy="4293706"/>
            <a:chOff x="390939" y="1131475"/>
            <a:chExt cx="9777743" cy="4293706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1DA8E501-AF86-4C9B-B949-D8E1618A97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90939" y="1131475"/>
              <a:ext cx="9777743" cy="4293706"/>
            </a:xfrm>
            <a:prstGeom prst="rect">
              <a:avLst/>
            </a:prstGeom>
          </p:spPr>
        </p:pic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649DFCDF-4CCB-4E5F-840A-DF8DD29D3A07}"/>
                </a:ext>
              </a:extLst>
            </p:cNvPr>
            <p:cNvSpPr/>
            <p:nvPr/>
          </p:nvSpPr>
          <p:spPr>
            <a:xfrm>
              <a:off x="429439" y="4351239"/>
              <a:ext cx="78899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Hans-HK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Ser473)</a:t>
              </a:r>
              <a:endParaRPr lang="zh-Hans-HK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DD8644B8-5C77-40BB-95E0-4DD1F9AD3686}"/>
                </a:ext>
              </a:extLst>
            </p:cNvPr>
            <p:cNvSpPr/>
            <p:nvPr/>
          </p:nvSpPr>
          <p:spPr>
            <a:xfrm>
              <a:off x="4181688" y="3916498"/>
              <a:ext cx="78899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Hans-HK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Ser473)</a:t>
              </a:r>
              <a:endParaRPr lang="zh-Hans-HK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6757161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>
            <a:extLst>
              <a:ext uri="{FF2B5EF4-FFF2-40B4-BE49-F238E27FC236}">
                <a16:creationId xmlns:a16="http://schemas.microsoft.com/office/drawing/2014/main" id="{15A0324E-54E8-4036-A5C2-4EC021A09589}"/>
              </a:ext>
            </a:extLst>
          </p:cNvPr>
          <p:cNvSpPr txBox="1"/>
          <p:nvPr/>
        </p:nvSpPr>
        <p:spPr>
          <a:xfrm>
            <a:off x="81665" y="115519"/>
            <a:ext cx="3641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5b </a:t>
            </a:r>
            <a:r>
              <a:rPr lang="en-US" altLang="zh-CN" b="1" dirty="0"/>
              <a:t>&amp; Supplementary Fig 6d -3</a:t>
            </a:r>
            <a:endParaRPr lang="zh-Hans-HK" altLang="en-US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8ABB330-A3E0-4C76-9484-67E7858FF131}"/>
              </a:ext>
            </a:extLst>
          </p:cNvPr>
          <p:cNvSpPr txBox="1"/>
          <p:nvPr/>
        </p:nvSpPr>
        <p:spPr>
          <a:xfrm>
            <a:off x="9134176" y="5724399"/>
            <a:ext cx="305782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9139;</a:t>
            </a:r>
            <a:endParaRPr lang="en-US" altLang="zh-Hans-HK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Phospho-STAT3 (</a:t>
            </a:r>
            <a:r>
              <a:rPr lang="en-US" altLang="zh-Hans-HK" sz="14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 Y705): 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cam, ab76315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63812CAC-A629-4225-9B19-3E4A762E19F2}"/>
              </a:ext>
            </a:extLst>
          </p:cNvPr>
          <p:cNvGrpSpPr/>
          <p:nvPr/>
        </p:nvGrpSpPr>
        <p:grpSpPr>
          <a:xfrm>
            <a:off x="535315" y="1074779"/>
            <a:ext cx="9516298" cy="4365663"/>
            <a:chOff x="535315" y="1074779"/>
            <a:chExt cx="9516298" cy="4365663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9D39AE01-5730-481C-AAFB-76134846A6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10666" y="1074779"/>
              <a:ext cx="9340947" cy="4365663"/>
            </a:xfrm>
            <a:prstGeom prst="rect">
              <a:avLst/>
            </a:prstGeom>
          </p:spPr>
        </p:pic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C050044D-FD83-465F-AF42-2DBEB1F4DF76}"/>
                </a:ext>
              </a:extLst>
            </p:cNvPr>
            <p:cNvSpPr/>
            <p:nvPr/>
          </p:nvSpPr>
          <p:spPr>
            <a:xfrm>
              <a:off x="535315" y="4634577"/>
              <a:ext cx="128272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Hans-HK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Hans-HK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en-US" altLang="zh-Hans-HK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Y705)</a:t>
              </a:r>
              <a:endParaRPr lang="zh-Hans-HK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F0914015-182A-4470-97DC-0B0175CD6227}"/>
                </a:ext>
              </a:extLst>
            </p:cNvPr>
            <p:cNvSpPr/>
            <p:nvPr/>
          </p:nvSpPr>
          <p:spPr>
            <a:xfrm>
              <a:off x="4316444" y="4545766"/>
              <a:ext cx="128272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Hans-HK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Hans-HK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en-US" altLang="zh-Hans-HK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Y705)</a:t>
              </a:r>
              <a:endParaRPr lang="zh-Hans-HK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7770813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>
            <a:extLst>
              <a:ext uri="{FF2B5EF4-FFF2-40B4-BE49-F238E27FC236}">
                <a16:creationId xmlns:a16="http://schemas.microsoft.com/office/drawing/2014/main" id="{15A0324E-54E8-4036-A5C2-4EC021A09589}"/>
              </a:ext>
            </a:extLst>
          </p:cNvPr>
          <p:cNvSpPr txBox="1"/>
          <p:nvPr/>
        </p:nvSpPr>
        <p:spPr>
          <a:xfrm>
            <a:off x="81665" y="259897"/>
            <a:ext cx="3641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5b </a:t>
            </a:r>
            <a:r>
              <a:rPr lang="en-US" altLang="zh-CN" b="1" dirty="0"/>
              <a:t>&amp; Supplementary Fig 6d -4</a:t>
            </a:r>
            <a:endParaRPr lang="zh-Hans-HK" altLang="en-US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8ABB330-A3E0-4C76-9484-67E7858FF131}"/>
              </a:ext>
            </a:extLst>
          </p:cNvPr>
          <p:cNvSpPr txBox="1"/>
          <p:nvPr/>
        </p:nvSpPr>
        <p:spPr>
          <a:xfrm>
            <a:off x="9134176" y="5724399"/>
            <a:ext cx="305782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-Jun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9165;</a:t>
            </a:r>
            <a:endParaRPr lang="en-US" altLang="zh-Hans-HK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BCL-XL: 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st2762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 descr="图示&#10;&#10;描述已自动生成">
            <a:extLst>
              <a:ext uri="{FF2B5EF4-FFF2-40B4-BE49-F238E27FC236}">
                <a16:creationId xmlns:a16="http://schemas.microsoft.com/office/drawing/2014/main" id="{1F0DE268-CA1A-43D4-9B3E-71F3607807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08535" y="1301817"/>
            <a:ext cx="9669014" cy="4254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87564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>
            <a:extLst>
              <a:ext uri="{FF2B5EF4-FFF2-40B4-BE49-F238E27FC236}">
                <a16:creationId xmlns:a16="http://schemas.microsoft.com/office/drawing/2014/main" id="{15A0324E-54E8-4036-A5C2-4EC021A09589}"/>
              </a:ext>
            </a:extLst>
          </p:cNvPr>
          <p:cNvSpPr txBox="1"/>
          <p:nvPr/>
        </p:nvSpPr>
        <p:spPr>
          <a:xfrm>
            <a:off x="81665" y="259897"/>
            <a:ext cx="1039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5c</a:t>
            </a:r>
            <a:endParaRPr lang="zh-Hans-HK" altLang="en-US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1BFCE7E-818A-429C-A332-FB1CEC3D565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495"/>
          <a:stretch/>
        </p:blipFill>
        <p:spPr>
          <a:xfrm>
            <a:off x="601519" y="662279"/>
            <a:ext cx="6211503" cy="535835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A4E1020-DCF3-4316-BF38-F60BEE51989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667101" y="1000062"/>
            <a:ext cx="3169920" cy="55778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90637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表格&#10;&#10;描述已自动生成">
            <a:extLst>
              <a:ext uri="{FF2B5EF4-FFF2-40B4-BE49-F238E27FC236}">
                <a16:creationId xmlns:a16="http://schemas.microsoft.com/office/drawing/2014/main" id="{10CFC2D9-0CD4-40D7-B2AA-48E65626F3B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57610" y="253388"/>
            <a:ext cx="6906383" cy="634571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3F61667-42D0-4EDA-8E83-547A8E9C68EF}"/>
              </a:ext>
            </a:extLst>
          </p:cNvPr>
          <p:cNvSpPr txBox="1"/>
          <p:nvPr/>
        </p:nvSpPr>
        <p:spPr>
          <a:xfrm>
            <a:off x="81665" y="259897"/>
            <a:ext cx="1066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5</a:t>
            </a:r>
            <a:r>
              <a:rPr lang="en-US" altLang="zh-CN" b="1" dirty="0"/>
              <a:t>d</a:t>
            </a:r>
            <a:endParaRPr lang="zh-Hans-HK" altLang="en-US" b="1" dirty="0"/>
          </a:p>
        </p:txBody>
      </p:sp>
    </p:spTree>
    <p:extLst>
      <p:ext uri="{BB962C8B-B14F-4D97-AF65-F5344CB8AC3E}">
        <p14:creationId xmlns:p14="http://schemas.microsoft.com/office/powerpoint/2010/main" val="150920863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图示&#10;&#10;描述已自动生成">
            <a:extLst>
              <a:ext uri="{FF2B5EF4-FFF2-40B4-BE49-F238E27FC236}">
                <a16:creationId xmlns:a16="http://schemas.microsoft.com/office/drawing/2014/main" id="{6B3C45C8-BAE8-4FAC-A32E-94DE4479E99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28" t="21273" r="9176" b="37528"/>
          <a:stretch/>
        </p:blipFill>
        <p:spPr>
          <a:xfrm>
            <a:off x="1325365" y="865638"/>
            <a:ext cx="6935057" cy="512672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5750E06-580A-4642-A0C8-0B735DC5F6DF}"/>
              </a:ext>
            </a:extLst>
          </p:cNvPr>
          <p:cNvSpPr txBox="1"/>
          <p:nvPr/>
        </p:nvSpPr>
        <p:spPr>
          <a:xfrm>
            <a:off x="81665" y="208526"/>
            <a:ext cx="1058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6e</a:t>
            </a:r>
            <a:endParaRPr lang="zh-Hans-HK" altLang="en-US" b="1" dirty="0"/>
          </a:p>
        </p:txBody>
      </p:sp>
    </p:spTree>
    <p:extLst>
      <p:ext uri="{BB962C8B-B14F-4D97-AF65-F5344CB8AC3E}">
        <p14:creationId xmlns:p14="http://schemas.microsoft.com/office/powerpoint/2010/main" val="7125946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D2925D8-BB56-4DC9-8BFA-1AC6E1971B7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878" t="12584" r="39852" b="62135"/>
          <a:stretch/>
        </p:blipFill>
        <p:spPr>
          <a:xfrm>
            <a:off x="503435" y="2170411"/>
            <a:ext cx="4798032" cy="173376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0C97AAE-EC4B-4D44-8CB1-48194DEED075}"/>
              </a:ext>
            </a:extLst>
          </p:cNvPr>
          <p:cNvSpPr txBox="1"/>
          <p:nvPr/>
        </p:nvSpPr>
        <p:spPr>
          <a:xfrm rot="16200000">
            <a:off x="1428605" y="1725234"/>
            <a:ext cx="546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LO2</a:t>
            </a:r>
            <a:endParaRPr lang="zh-Hans-HK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82A5DDC-54FC-413D-9912-DD96AE4CDB58}"/>
              </a:ext>
            </a:extLst>
          </p:cNvPr>
          <p:cNvSpPr txBox="1"/>
          <p:nvPr/>
        </p:nvSpPr>
        <p:spPr>
          <a:xfrm rot="16200000">
            <a:off x="1764220" y="1640146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MIHA</a:t>
            </a:r>
            <a:endParaRPr lang="zh-Hans-HK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AE0F719-8B25-40C5-A1FC-6B82376C2356}"/>
              </a:ext>
            </a:extLst>
          </p:cNvPr>
          <p:cNvSpPr txBox="1"/>
          <p:nvPr/>
        </p:nvSpPr>
        <p:spPr>
          <a:xfrm rot="16200000">
            <a:off x="2137854" y="1596063"/>
            <a:ext cx="805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Hep3b</a:t>
            </a:r>
            <a:endParaRPr lang="zh-Hans-HK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88A1578-1A1A-415A-BF83-C993DB1828B5}"/>
              </a:ext>
            </a:extLst>
          </p:cNvPr>
          <p:cNvSpPr txBox="1"/>
          <p:nvPr/>
        </p:nvSpPr>
        <p:spPr>
          <a:xfrm rot="16200000">
            <a:off x="2525987" y="1584041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HepG2</a:t>
            </a:r>
            <a:endParaRPr lang="zh-Hans-HK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434216A-4F12-4529-BD81-59D7F3001DAE}"/>
              </a:ext>
            </a:extLst>
          </p:cNvPr>
          <p:cNvSpPr txBox="1"/>
          <p:nvPr/>
        </p:nvSpPr>
        <p:spPr>
          <a:xfrm rot="16200000">
            <a:off x="3031358" y="1653772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Huh7</a:t>
            </a:r>
            <a:endParaRPr lang="zh-Hans-HK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DDBA591-C514-46F8-A8AC-F639D7BDD3B0}"/>
              </a:ext>
            </a:extLst>
          </p:cNvPr>
          <p:cNvSpPr txBox="1"/>
          <p:nvPr/>
        </p:nvSpPr>
        <p:spPr>
          <a:xfrm rot="16200000">
            <a:off x="3474210" y="1672206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8024</a:t>
            </a:r>
            <a:endParaRPr lang="zh-Hans-HK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DD4DC39-7DF0-4DA1-A60D-D4E3D0E9FBBF}"/>
              </a:ext>
            </a:extLst>
          </p:cNvPr>
          <p:cNvSpPr txBox="1"/>
          <p:nvPr/>
        </p:nvSpPr>
        <p:spPr>
          <a:xfrm rot="16200000">
            <a:off x="3956338" y="1740334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97L</a:t>
            </a:r>
            <a:endParaRPr lang="zh-Hans-HK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D23C1F8-8F49-4847-8D9E-59B25B48E042}"/>
              </a:ext>
            </a:extLst>
          </p:cNvPr>
          <p:cNvSpPr txBox="1"/>
          <p:nvPr/>
        </p:nvSpPr>
        <p:spPr>
          <a:xfrm rot="16200000">
            <a:off x="4342722" y="1716289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H2P</a:t>
            </a:r>
            <a:endParaRPr lang="zh-Hans-HK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F4A3DB8-B5B2-4467-AE17-922DB3629E84}"/>
              </a:ext>
            </a:extLst>
          </p:cNvPr>
          <p:cNvSpPr txBox="1"/>
          <p:nvPr/>
        </p:nvSpPr>
        <p:spPr>
          <a:xfrm rot="16200000">
            <a:off x="4658538" y="1632607"/>
            <a:ext cx="731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ans-HK" dirty="0"/>
              <a:t>H2M</a:t>
            </a:r>
            <a:endParaRPr lang="zh-Hans-HK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A032A37-851C-4CE4-8747-BA63BF492F9B}"/>
              </a:ext>
            </a:extLst>
          </p:cNvPr>
          <p:cNvSpPr txBox="1"/>
          <p:nvPr/>
        </p:nvSpPr>
        <p:spPr>
          <a:xfrm rot="16200000">
            <a:off x="955531" y="1672206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>
                <a:solidFill>
                  <a:schemeClr val="tx1">
                    <a:lumMod val="50000"/>
                    <a:lumOff val="50000"/>
                  </a:schemeClr>
                </a:solidFill>
              </a:rPr>
              <a:t>7402</a:t>
            </a:r>
            <a:endParaRPr lang="zh-Hans-HK" altLang="en-US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F0A853A-CF92-4A7E-BBA7-EB5D12C3FFF9}"/>
              </a:ext>
            </a:extLst>
          </p:cNvPr>
          <p:cNvSpPr txBox="1"/>
          <p:nvPr/>
        </p:nvSpPr>
        <p:spPr>
          <a:xfrm>
            <a:off x="5301467" y="2774018"/>
            <a:ext cx="802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-RALYL</a:t>
            </a:r>
            <a:endParaRPr lang="zh-Hans-HK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5AF000C-6CB8-4AF5-823E-AFD90A7F56BC}"/>
              </a:ext>
            </a:extLst>
          </p:cNvPr>
          <p:cNvSpPr txBox="1"/>
          <p:nvPr/>
        </p:nvSpPr>
        <p:spPr>
          <a:xfrm>
            <a:off x="5293101" y="454485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-18</a:t>
            </a:r>
            <a:endParaRPr lang="zh-Hans-HK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6B34AB8-043A-46F1-9B30-EE670DF2A670}"/>
              </a:ext>
            </a:extLst>
          </p:cNvPr>
          <p:cNvSpPr txBox="1"/>
          <p:nvPr/>
        </p:nvSpPr>
        <p:spPr>
          <a:xfrm>
            <a:off x="648753" y="392052"/>
            <a:ext cx="2578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S</a:t>
            </a:r>
            <a:r>
              <a:rPr lang="en-US" altLang="zh-CN" b="1" dirty="0"/>
              <a:t>upplementary </a:t>
            </a:r>
            <a:r>
              <a:rPr lang="en-US" altLang="zh-Hans-HK" b="1" dirty="0"/>
              <a:t>Figure 1</a:t>
            </a:r>
            <a:r>
              <a:rPr lang="en-US" altLang="zh-CN" b="1" dirty="0"/>
              <a:t>d</a:t>
            </a:r>
            <a:endParaRPr lang="zh-Hans-HK" altLang="en-US" b="1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B896CF2D-7B45-47F7-B6F8-81C317353A6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878" t="54511" r="39852" b="22246"/>
          <a:stretch/>
        </p:blipFill>
        <p:spPr>
          <a:xfrm>
            <a:off x="495069" y="4003750"/>
            <a:ext cx="4798032" cy="1593949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60B7FAE2-C797-4A54-B7F0-9D672F6ABAC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3" t="36256" r="15468" b="33739"/>
          <a:stretch/>
        </p:blipFill>
        <p:spPr>
          <a:xfrm>
            <a:off x="6580479" y="2063554"/>
            <a:ext cx="5365623" cy="299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98992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电脑主机&#10;&#10;描述已自动生成">
            <a:extLst>
              <a:ext uri="{FF2B5EF4-FFF2-40B4-BE49-F238E27FC236}">
                <a16:creationId xmlns:a16="http://schemas.microsoft.com/office/drawing/2014/main" id="{2EDEACCB-A52B-42BD-8D77-93AA095D82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383356" y="2034323"/>
            <a:ext cx="1093304" cy="187213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BE80BA1-B4E0-41F2-8E60-C0F59C6F552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05897" y="2025805"/>
            <a:ext cx="1694860" cy="187213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2C0C3DB-6C2A-40AD-82F2-4876C5A95AE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3807233" y="2025805"/>
            <a:ext cx="991517" cy="1872134"/>
          </a:xfrm>
          <a:prstGeom prst="rect">
            <a:avLst/>
          </a:prstGeom>
        </p:spPr>
      </p:pic>
      <p:pic>
        <p:nvPicPr>
          <p:cNvPr id="11" name="图片 10" descr="电脑主机&#10;&#10;描述已自动生成">
            <a:extLst>
              <a:ext uri="{FF2B5EF4-FFF2-40B4-BE49-F238E27FC236}">
                <a16:creationId xmlns:a16="http://schemas.microsoft.com/office/drawing/2014/main" id="{77FD4765-6FA5-47B7-9EFF-CF971606224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175009" y="2034323"/>
            <a:ext cx="1597717" cy="1872134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78A74F25-F98D-444E-BED2-4BE65197F364}"/>
              </a:ext>
            </a:extLst>
          </p:cNvPr>
          <p:cNvSpPr txBox="1"/>
          <p:nvPr/>
        </p:nvSpPr>
        <p:spPr>
          <a:xfrm>
            <a:off x="246580" y="247566"/>
            <a:ext cx="1039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1c</a:t>
            </a:r>
            <a:endParaRPr lang="zh-Hans-HK" altLang="en-US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20B3223-A064-4B6A-A38B-A671D174B07F}"/>
              </a:ext>
            </a:extLst>
          </p:cNvPr>
          <p:cNvSpPr txBox="1"/>
          <p:nvPr/>
        </p:nvSpPr>
        <p:spPr>
          <a:xfrm>
            <a:off x="1920837" y="1280518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Huh7</a:t>
            </a:r>
            <a:endParaRPr lang="zh-Hans-HK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0F7876F-0929-4C21-8A22-3A981A264137}"/>
              </a:ext>
            </a:extLst>
          </p:cNvPr>
          <p:cNvSpPr txBox="1"/>
          <p:nvPr/>
        </p:nvSpPr>
        <p:spPr>
          <a:xfrm>
            <a:off x="1447987" y="1664426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CD133-</a:t>
            </a:r>
            <a:endParaRPr lang="zh-Hans-HK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D79B339-432A-454C-8124-938628133BE2}"/>
              </a:ext>
            </a:extLst>
          </p:cNvPr>
          <p:cNvSpPr txBox="1"/>
          <p:nvPr/>
        </p:nvSpPr>
        <p:spPr>
          <a:xfrm>
            <a:off x="2226245" y="1665057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CD133+</a:t>
            </a:r>
            <a:endParaRPr lang="zh-Hans-HK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6F8D5D2-B468-4968-9038-46994811E0C7}"/>
              </a:ext>
            </a:extLst>
          </p:cNvPr>
          <p:cNvSpPr txBox="1"/>
          <p:nvPr/>
        </p:nvSpPr>
        <p:spPr>
          <a:xfrm>
            <a:off x="4012207" y="1267663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Huh7</a:t>
            </a:r>
            <a:endParaRPr lang="zh-Hans-HK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FFC503C-A075-4908-BD4D-392A4BBDCA79}"/>
              </a:ext>
            </a:extLst>
          </p:cNvPr>
          <p:cNvSpPr txBox="1"/>
          <p:nvPr/>
        </p:nvSpPr>
        <p:spPr>
          <a:xfrm>
            <a:off x="3539357" y="1651571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CD133-</a:t>
            </a:r>
            <a:endParaRPr lang="zh-Hans-HK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86ED8BF-2277-4AB5-90E4-C51EF9752E8E}"/>
              </a:ext>
            </a:extLst>
          </p:cNvPr>
          <p:cNvSpPr txBox="1"/>
          <p:nvPr/>
        </p:nvSpPr>
        <p:spPr>
          <a:xfrm>
            <a:off x="4317615" y="1652202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CD133+</a:t>
            </a:r>
            <a:endParaRPr lang="zh-Hans-HK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FD75484-DFB0-43B4-956D-386057511227}"/>
              </a:ext>
            </a:extLst>
          </p:cNvPr>
          <p:cNvSpPr txBox="1"/>
          <p:nvPr/>
        </p:nvSpPr>
        <p:spPr>
          <a:xfrm>
            <a:off x="2752846" y="2550295"/>
            <a:ext cx="802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-RALYL</a:t>
            </a:r>
            <a:endParaRPr lang="zh-Hans-HK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49D3129-9917-481C-A674-362081401F5A}"/>
              </a:ext>
            </a:extLst>
          </p:cNvPr>
          <p:cNvSpPr txBox="1"/>
          <p:nvPr/>
        </p:nvSpPr>
        <p:spPr>
          <a:xfrm>
            <a:off x="4759410" y="2592540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-18s</a:t>
            </a:r>
            <a:endParaRPr lang="zh-Hans-HK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275CF1A-BA84-4EC1-9C45-F88277457156}"/>
              </a:ext>
            </a:extLst>
          </p:cNvPr>
          <p:cNvSpPr txBox="1"/>
          <p:nvPr/>
        </p:nvSpPr>
        <p:spPr>
          <a:xfrm>
            <a:off x="6598745" y="1293373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Hep3B</a:t>
            </a:r>
            <a:endParaRPr lang="zh-Hans-HK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3F4A009-D619-4C01-9ADC-283F714AD888}"/>
              </a:ext>
            </a:extLst>
          </p:cNvPr>
          <p:cNvSpPr txBox="1"/>
          <p:nvPr/>
        </p:nvSpPr>
        <p:spPr>
          <a:xfrm>
            <a:off x="6125895" y="1677281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CD133-</a:t>
            </a:r>
            <a:endParaRPr lang="zh-Hans-HK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CEB984A-C638-40C1-9114-3B8C03A44CB8}"/>
              </a:ext>
            </a:extLst>
          </p:cNvPr>
          <p:cNvSpPr txBox="1"/>
          <p:nvPr/>
        </p:nvSpPr>
        <p:spPr>
          <a:xfrm>
            <a:off x="6904153" y="1677912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CD133+</a:t>
            </a:r>
            <a:endParaRPr lang="zh-Hans-HK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042D7F7-2DAB-4EC4-97BF-340F0E95A5A2}"/>
              </a:ext>
            </a:extLst>
          </p:cNvPr>
          <p:cNvSpPr txBox="1"/>
          <p:nvPr/>
        </p:nvSpPr>
        <p:spPr>
          <a:xfrm>
            <a:off x="8866387" y="1280518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Hep3B</a:t>
            </a:r>
            <a:endParaRPr lang="zh-Hans-HK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3AB3DAD-F906-49B2-8B90-F16FFBDD3D8E}"/>
              </a:ext>
            </a:extLst>
          </p:cNvPr>
          <p:cNvSpPr txBox="1"/>
          <p:nvPr/>
        </p:nvSpPr>
        <p:spPr>
          <a:xfrm>
            <a:off x="8393537" y="1664426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CD133-</a:t>
            </a:r>
            <a:endParaRPr lang="zh-Hans-HK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B5B660A-62AD-430D-B86A-8F0013C4897D}"/>
              </a:ext>
            </a:extLst>
          </p:cNvPr>
          <p:cNvSpPr txBox="1"/>
          <p:nvPr/>
        </p:nvSpPr>
        <p:spPr>
          <a:xfrm>
            <a:off x="9171795" y="1665057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CD133+</a:t>
            </a:r>
            <a:endParaRPr lang="zh-Hans-HK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2B7C13A-C90C-43B9-87FF-FCFCE5548851}"/>
              </a:ext>
            </a:extLst>
          </p:cNvPr>
          <p:cNvSpPr txBox="1"/>
          <p:nvPr/>
        </p:nvSpPr>
        <p:spPr>
          <a:xfrm>
            <a:off x="7430754" y="2629252"/>
            <a:ext cx="802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-RALYL</a:t>
            </a:r>
            <a:endParaRPr lang="zh-Hans-HK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EAA1660-13B5-45EA-B6EF-93051A59F0DF}"/>
              </a:ext>
            </a:extLst>
          </p:cNvPr>
          <p:cNvSpPr txBox="1"/>
          <p:nvPr/>
        </p:nvSpPr>
        <p:spPr>
          <a:xfrm>
            <a:off x="9756808" y="2748616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dirty="0"/>
              <a:t>-18s</a:t>
            </a:r>
            <a:endParaRPr lang="zh-Hans-HK" altLang="en-US" dirty="0"/>
          </a:p>
        </p:txBody>
      </p:sp>
    </p:spTree>
    <p:extLst>
      <p:ext uri="{BB962C8B-B14F-4D97-AF65-F5344CB8AC3E}">
        <p14:creationId xmlns:p14="http://schemas.microsoft.com/office/powerpoint/2010/main" val="1937357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9AF4D1C-9EA9-4FDC-8631-4E90FC5AD960}"/>
              </a:ext>
            </a:extLst>
          </p:cNvPr>
          <p:cNvSpPr txBox="1"/>
          <p:nvPr/>
        </p:nvSpPr>
        <p:spPr>
          <a:xfrm>
            <a:off x="246580" y="247566"/>
            <a:ext cx="3391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2a </a:t>
            </a:r>
            <a:r>
              <a:rPr lang="en-US" altLang="zh-CN" b="1" dirty="0"/>
              <a:t>&amp; Supplementary Fig 2a</a:t>
            </a:r>
            <a:endParaRPr lang="zh-Hans-HK" altLang="en-US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D3BC598-2EA4-486A-87D8-0C98F1E4200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15657" y="789276"/>
            <a:ext cx="3932405" cy="4417996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F39C743D-AB45-4899-840A-E15CC169FD2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543913" y="818153"/>
            <a:ext cx="6155002" cy="441799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7AA85419-D7E1-41D1-9B04-1C9E40B594E6}"/>
              </a:ext>
            </a:extLst>
          </p:cNvPr>
          <p:cNvSpPr txBox="1"/>
          <p:nvPr/>
        </p:nvSpPr>
        <p:spPr>
          <a:xfrm>
            <a:off x="914400" y="5313145"/>
            <a:ext cx="243694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RALYL: Sigma, HPA059112;</a:t>
            </a:r>
          </a:p>
          <a:p>
            <a:r>
              <a:rPr lang="el-GR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actin: Abcam, ab6276.</a:t>
            </a:r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50819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 descr="图示&#10;&#10;描述已自动生成">
            <a:extLst>
              <a:ext uri="{FF2B5EF4-FFF2-40B4-BE49-F238E27FC236}">
                <a16:creationId xmlns:a16="http://schemas.microsoft.com/office/drawing/2014/main" id="{A3A9D580-4AFC-4005-BDFB-A8252037A6E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86050" y="432232"/>
            <a:ext cx="7563521" cy="6178202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1E4498A3-7FC9-4C04-A79E-530FF7C277D2}"/>
              </a:ext>
            </a:extLst>
          </p:cNvPr>
          <p:cNvSpPr txBox="1"/>
          <p:nvPr/>
        </p:nvSpPr>
        <p:spPr>
          <a:xfrm>
            <a:off x="246580" y="247566"/>
            <a:ext cx="1254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3d</a:t>
            </a:r>
            <a:r>
              <a:rPr lang="en-US" altLang="zh-CN" b="1" dirty="0"/>
              <a:t>-1</a:t>
            </a:r>
            <a:endParaRPr lang="zh-Hans-HK" altLang="en-US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9F5B04C-FD85-4AF3-98E0-67F758FC727D}"/>
              </a:ext>
            </a:extLst>
          </p:cNvPr>
          <p:cNvSpPr txBox="1"/>
          <p:nvPr/>
        </p:nvSpPr>
        <p:spPr>
          <a:xfrm>
            <a:off x="3041585" y="2750777"/>
            <a:ext cx="12218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sz="1000" b="1" dirty="0">
                <a:latin typeface="Arial" panose="020B0604020202020204" pitchFamily="34" charset="0"/>
                <a:cs typeface="Arial" panose="020B0604020202020204" pitchFamily="34" charset="0"/>
              </a:rPr>
              <a:t>Longer exposure</a:t>
            </a:r>
            <a:endParaRPr lang="zh-Hans-HK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C1ABEEA-9A12-4548-B733-2FD4E8D13021}"/>
              </a:ext>
            </a:extLst>
          </p:cNvPr>
          <p:cNvSpPr txBox="1"/>
          <p:nvPr/>
        </p:nvSpPr>
        <p:spPr>
          <a:xfrm>
            <a:off x="5013157" y="5735053"/>
            <a:ext cx="12218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sz="1000" b="1" dirty="0">
                <a:latin typeface="Arial" panose="020B0604020202020204" pitchFamily="34" charset="0"/>
                <a:cs typeface="Arial" panose="020B0604020202020204" pitchFamily="34" charset="0"/>
              </a:rPr>
              <a:t>Longer exposure</a:t>
            </a:r>
            <a:endParaRPr lang="zh-Hans-HK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665F0207-7666-4844-8148-D8EE03EC2238}"/>
              </a:ext>
            </a:extLst>
          </p:cNvPr>
          <p:cNvSpPr txBox="1"/>
          <p:nvPr/>
        </p:nvSpPr>
        <p:spPr>
          <a:xfrm>
            <a:off x="780059" y="5951463"/>
            <a:ext cx="313688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E-cadherin: Cell signaling, cst3195;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N-cadherin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13116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9768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ACCFBA5-DC1A-47D6-8EDE-C5D8AA8F2C0E}"/>
              </a:ext>
            </a:extLst>
          </p:cNvPr>
          <p:cNvSpPr txBox="1"/>
          <p:nvPr/>
        </p:nvSpPr>
        <p:spPr>
          <a:xfrm>
            <a:off x="246580" y="247566"/>
            <a:ext cx="1254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3d</a:t>
            </a:r>
            <a:r>
              <a:rPr lang="en-US" altLang="zh-CN" b="1" dirty="0"/>
              <a:t>-2</a:t>
            </a:r>
            <a:endParaRPr lang="zh-Hans-HK" altLang="en-US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2164A87-5FF5-4D14-8D68-A8FF221F2AA1}"/>
              </a:ext>
            </a:extLst>
          </p:cNvPr>
          <p:cNvSpPr txBox="1"/>
          <p:nvPr/>
        </p:nvSpPr>
        <p:spPr>
          <a:xfrm>
            <a:off x="587553" y="5866398"/>
            <a:ext cx="2462277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bca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ab2413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 descr="图示&#10;&#10;描述已自动生成">
            <a:extLst>
              <a:ext uri="{FF2B5EF4-FFF2-40B4-BE49-F238E27FC236}">
                <a16:creationId xmlns:a16="http://schemas.microsoft.com/office/drawing/2014/main" id="{34F2CBAE-B23C-47AE-9BAD-CC86E2FF313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60921" y="1029902"/>
            <a:ext cx="8892535" cy="37442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18133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 descr="图示&#10;&#10;描述已自动生成">
            <a:extLst>
              <a:ext uri="{FF2B5EF4-FFF2-40B4-BE49-F238E27FC236}">
                <a16:creationId xmlns:a16="http://schemas.microsoft.com/office/drawing/2014/main" id="{F597FC88-5694-460C-9AA3-DE8D17C208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76976" y="4292270"/>
            <a:ext cx="9378279" cy="2250787"/>
          </a:xfrm>
          <a:prstGeom prst="rect">
            <a:avLst/>
          </a:prstGeom>
        </p:spPr>
      </p:pic>
      <p:pic>
        <p:nvPicPr>
          <p:cNvPr id="30" name="图片 29" descr="图示&#10;&#10;描述已自动生成">
            <a:extLst>
              <a:ext uri="{FF2B5EF4-FFF2-40B4-BE49-F238E27FC236}">
                <a16:creationId xmlns:a16="http://schemas.microsoft.com/office/drawing/2014/main" id="{B1059688-B205-4C8D-8F1A-FC87078227A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03721" y="225602"/>
            <a:ext cx="9378280" cy="3929005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768253F1-6EA1-4339-8923-3B1B59C9B8EE}"/>
              </a:ext>
            </a:extLst>
          </p:cNvPr>
          <p:cNvSpPr txBox="1"/>
          <p:nvPr/>
        </p:nvSpPr>
        <p:spPr>
          <a:xfrm>
            <a:off x="246580" y="247566"/>
            <a:ext cx="1254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3d</a:t>
            </a:r>
            <a:r>
              <a:rPr lang="en-US" altLang="zh-CN" b="1" dirty="0"/>
              <a:t>-3</a:t>
            </a:r>
            <a:endParaRPr lang="zh-Hans-HK" altLang="en-US" b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4053C49-0C8B-4F28-9BEE-2C8C28FFE88C}"/>
              </a:ext>
            </a:extLst>
          </p:cNvPr>
          <p:cNvSpPr txBox="1"/>
          <p:nvPr/>
        </p:nvSpPr>
        <p:spPr>
          <a:xfrm>
            <a:off x="9308041" y="5678291"/>
            <a:ext cx="248497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ail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ell signaling, cst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879</a:t>
            </a:r>
            <a:endParaRPr lang="en-US" altLang="zh-Hans-HK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lug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9585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77601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>
            <a:extLst>
              <a:ext uri="{FF2B5EF4-FFF2-40B4-BE49-F238E27FC236}">
                <a16:creationId xmlns:a16="http://schemas.microsoft.com/office/drawing/2014/main" id="{A607979D-FD93-4F4B-86F6-97DD5CCB65EA}"/>
              </a:ext>
            </a:extLst>
          </p:cNvPr>
          <p:cNvSpPr txBox="1"/>
          <p:nvPr/>
        </p:nvSpPr>
        <p:spPr>
          <a:xfrm>
            <a:off x="81665" y="115519"/>
            <a:ext cx="3631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4a</a:t>
            </a:r>
            <a:r>
              <a:rPr lang="en-US" altLang="zh-CN" b="1" dirty="0"/>
              <a:t> &amp; Supplementary Fig 4a -1</a:t>
            </a:r>
            <a:endParaRPr lang="zh-Hans-HK" altLang="en-US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0C52AF2-055A-4129-A0C0-0DF27B725E6B}"/>
              </a:ext>
            </a:extLst>
          </p:cNvPr>
          <p:cNvSpPr txBox="1"/>
          <p:nvPr/>
        </p:nvSpPr>
        <p:spPr>
          <a:xfrm>
            <a:off x="645601" y="5322156"/>
            <a:ext cx="2184957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F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cam, ab3980;</a:t>
            </a:r>
            <a:endParaRPr lang="en-US" altLang="zh-Hans-HK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133: Abcam, ab19898</a:t>
            </a: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OX2: Abcam, ab92494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B3712CC-A967-49BB-886F-CA825C2F28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29401" y="870497"/>
            <a:ext cx="6545026" cy="3348275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ECB94C1B-D8C0-4D5E-94D1-45FF84B3585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646974" y="890336"/>
            <a:ext cx="6545026" cy="4711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59486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文本框 37">
            <a:extLst>
              <a:ext uri="{FF2B5EF4-FFF2-40B4-BE49-F238E27FC236}">
                <a16:creationId xmlns:a16="http://schemas.microsoft.com/office/drawing/2014/main" id="{A9D9DEB6-BABA-44F3-BEBD-E319AAD0322A}"/>
              </a:ext>
            </a:extLst>
          </p:cNvPr>
          <p:cNvSpPr txBox="1"/>
          <p:nvPr/>
        </p:nvSpPr>
        <p:spPr>
          <a:xfrm>
            <a:off x="81665" y="115519"/>
            <a:ext cx="3631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4a</a:t>
            </a:r>
            <a:r>
              <a:rPr lang="en-US" altLang="zh-CN" b="1" dirty="0"/>
              <a:t> &amp; Supplementary Fig 4a -2</a:t>
            </a:r>
            <a:endParaRPr lang="zh-Hans-HK" altLang="en-US" b="1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0D7B44F-B10E-4418-95A4-B498994FD4FB}"/>
              </a:ext>
            </a:extLst>
          </p:cNvPr>
          <p:cNvSpPr txBox="1"/>
          <p:nvPr/>
        </p:nvSpPr>
        <p:spPr>
          <a:xfrm>
            <a:off x="645601" y="5322156"/>
            <a:ext cx="278473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Antibodies used:</a:t>
            </a:r>
          </a:p>
          <a:p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zh-Hans-HK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Invitroge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132-500;</a:t>
            </a:r>
            <a:endParaRPr lang="en-US" altLang="zh-Hans-HK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ANOG: 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Cell signalin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cst4903</a:t>
            </a:r>
            <a:r>
              <a:rPr lang="en-US" altLang="zh-Hans-HK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zh-Hans-HK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7E2AE991-A949-4B5D-9B41-1931E217193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98120" y="1169926"/>
            <a:ext cx="6464435" cy="3467155"/>
          </a:xfrm>
          <a:prstGeom prst="rect">
            <a:avLst/>
          </a:prstGeom>
        </p:spPr>
      </p:pic>
      <p:pic>
        <p:nvPicPr>
          <p:cNvPr id="10" name="图片 9" descr="图示&#10;&#10;描述已自动生成">
            <a:extLst>
              <a:ext uri="{FF2B5EF4-FFF2-40B4-BE49-F238E27FC236}">
                <a16:creationId xmlns:a16="http://schemas.microsoft.com/office/drawing/2014/main" id="{4B49E94C-444F-4963-9497-011D86498AE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040880" y="1299237"/>
            <a:ext cx="5151120" cy="4259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88707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E2076BF-E9AB-41A9-81B3-4CE1D45078DF}"/>
              </a:ext>
            </a:extLst>
          </p:cNvPr>
          <p:cNvSpPr txBox="1"/>
          <p:nvPr/>
        </p:nvSpPr>
        <p:spPr>
          <a:xfrm>
            <a:off x="81665" y="115519"/>
            <a:ext cx="1057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ans-HK" b="1" dirty="0"/>
              <a:t>Figure 5a</a:t>
            </a:r>
            <a:endParaRPr lang="zh-Hans-HK" altLang="en-US" b="1" dirty="0"/>
          </a:p>
        </p:txBody>
      </p:sp>
      <p:pic>
        <p:nvPicPr>
          <p:cNvPr id="3" name="图片 2" descr="图片包含 图表&#10;&#10;描述已自动生成">
            <a:extLst>
              <a:ext uri="{FF2B5EF4-FFF2-40B4-BE49-F238E27FC236}">
                <a16:creationId xmlns:a16="http://schemas.microsoft.com/office/drawing/2014/main" id="{D596D7EF-B207-4874-BF4C-A88C1214798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4" t="4177" r="56344" b="70602"/>
          <a:stretch/>
        </p:blipFill>
        <p:spPr>
          <a:xfrm>
            <a:off x="1139006" y="1109949"/>
            <a:ext cx="4342680" cy="4638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3067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45</TotalTime>
  <Words>321</Words>
  <Application>Microsoft Office PowerPoint</Application>
  <PresentationFormat>宽屏</PresentationFormat>
  <Paragraphs>83</Paragraphs>
  <Slides>1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主题​​</vt:lpstr>
      <vt:lpstr>Wang et al. uncropped versions of gels or blot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Xia</dc:creator>
  <cp:lastModifiedBy>WANG Xia</cp:lastModifiedBy>
  <cp:revision>144</cp:revision>
  <dcterms:created xsi:type="dcterms:W3CDTF">2020-08-11T12:45:17Z</dcterms:created>
  <dcterms:modified xsi:type="dcterms:W3CDTF">2021-01-30T13:12:33Z</dcterms:modified>
</cp:coreProperties>
</file>